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>
      <p:cViewPr varScale="1">
        <p:scale>
          <a:sx n="73" d="100"/>
          <a:sy n="73" d="100"/>
        </p:scale>
        <p:origin x="61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228600" cy="2286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659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068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831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116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608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921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850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14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812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049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914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172D9-7ADB-48D0-812A-B4F41D6CD95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8CB36-C9B9-45A8-BB53-443A93EFE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827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3095" y="685800"/>
            <a:ext cx="10345809" cy="489551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7954" y="180201"/>
            <a:ext cx="1920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.1.  </a:t>
            </a:r>
            <a:endParaRPr lang="en-US" sz="12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10362" y="5559718"/>
            <a:ext cx="1185429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C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Supplemental </a:t>
            </a:r>
            <a:r>
              <a:rPr lang="en-US" sz="1200" b="1" dirty="0" smtClean="0">
                <a:solidFill>
                  <a:srgbClr val="C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figure.1.</a:t>
            </a:r>
            <a:r>
              <a:rPr lang="en-US" sz="1200" dirty="0" smtClean="0">
                <a:solidFill>
                  <a:srgbClr val="C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INS-1 Cells were treated with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PPAR</a:t>
            </a:r>
            <a:r>
              <a:rPr lang="el-GR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γ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 antagonist GW9662(10uM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) along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with Pioglitazone(10uM) in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high glucose (30mM)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conditions for 36h. Protein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levels were quantified via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immunoblotting</a:t>
            </a:r>
            <a:r>
              <a:rPr lang="en-US" sz="1200" dirty="0" smtClean="0"/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 Control, 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 HG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 (B)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INS-1 cells or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were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treated with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proteasomal inhibitor MG132 (10uM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) for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1h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and then exposed to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high glucose (30mM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) for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indicated time points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 Control, 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 0.005 v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G)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65685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6635" y="1389711"/>
            <a:ext cx="7498730" cy="407857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7954" y="199620"/>
            <a:ext cx="1999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.2.  </a:t>
            </a:r>
            <a:endParaRPr lang="en-US" sz="12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10362" y="5590981"/>
            <a:ext cx="1189029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C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Supplemental </a:t>
            </a:r>
            <a:r>
              <a:rPr lang="en-US" sz="1200" b="1" dirty="0" smtClean="0">
                <a:solidFill>
                  <a:srgbClr val="C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figure.2.</a:t>
            </a:r>
            <a:r>
              <a:rPr lang="en-US" sz="1200" dirty="0" smtClean="0">
                <a:solidFill>
                  <a:srgbClr val="C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(A) </a:t>
            </a:r>
            <a:r>
              <a:rPr lang="en-US" sz="1200" dirty="0" smtClean="0">
                <a:solidFill>
                  <a:srgbClr val="C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INS-1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Cells were treated with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Pioglitazone(10uM) in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high glucose (30mM)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conditions with Glutaminase inhibitor BPTES (10uM) for 36h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proteins were quantified via immunoblott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 &lt; 0.005 vs. control; 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 &lt; 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 HG;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 &lt; 0.005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O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63792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7905" y="685800"/>
            <a:ext cx="8096190" cy="490770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7954" y="199620"/>
            <a:ext cx="1920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.3.  </a:t>
            </a:r>
            <a:endParaRPr lang="en-US" sz="12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10362" y="5810042"/>
            <a:ext cx="1185429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C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Supplemental </a:t>
            </a:r>
            <a:r>
              <a:rPr lang="en-US" sz="1200" b="1" dirty="0" smtClean="0">
                <a:solidFill>
                  <a:srgbClr val="C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figure.3.</a:t>
            </a:r>
            <a:r>
              <a:rPr lang="en-US" sz="1200" dirty="0" smtClean="0">
                <a:solidFill>
                  <a:srgbClr val="C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INS-1 Cells were treated with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Pioglitazone(10uM) in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high glucose (30mM)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conditions for 36h. Protein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levels were quantified via immunoblott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0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 Control, 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0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 HG).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 (B)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INS-1 cells or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were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treated with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AMPK inhibitor BML-275 (10uM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)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along with pioglitazone(10uM) in high glucose (30mM) conditions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for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</a:rPr>
              <a:t>36h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 &lt; 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0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 control; 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 &lt; 0.005 vs. HG;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 &lt; 0.005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O;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&lt; 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O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2417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</TotalTime>
  <Words>219</Words>
  <Application>Microsoft Office PowerPoint</Application>
  <PresentationFormat>Widescreen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Muththaiyan D.</cp:lastModifiedBy>
  <cp:revision>12</cp:revision>
  <dcterms:created xsi:type="dcterms:W3CDTF">2021-01-09T23:34:33Z</dcterms:created>
  <dcterms:modified xsi:type="dcterms:W3CDTF">2021-06-02T14:04:43Z</dcterms:modified>
</cp:coreProperties>
</file>